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88163" cy="10018713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9" d="100"/>
          <a:sy n="99" d="100"/>
        </p:scale>
        <p:origin x="-240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F43A8F-00EA-452F-8500-B36CBE6266D9}" type="datetimeFigureOut">
              <a:rPr lang="es-ES" smtClean="0"/>
              <a:t>28/06/2017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70865-8AB7-497D-8463-1EEFAD81E5C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883819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F43A8F-00EA-452F-8500-B36CBE6266D9}" type="datetimeFigureOut">
              <a:rPr lang="es-ES" smtClean="0"/>
              <a:t>28/06/2017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70865-8AB7-497D-8463-1EEFAD81E5C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422314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F43A8F-00EA-452F-8500-B36CBE6266D9}" type="datetimeFigureOut">
              <a:rPr lang="es-ES" smtClean="0"/>
              <a:t>28/06/2017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70865-8AB7-497D-8463-1EEFAD81E5C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228374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F43A8F-00EA-452F-8500-B36CBE6266D9}" type="datetimeFigureOut">
              <a:rPr lang="es-ES" smtClean="0"/>
              <a:t>28/06/2017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70865-8AB7-497D-8463-1EEFAD81E5C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906243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F43A8F-00EA-452F-8500-B36CBE6266D9}" type="datetimeFigureOut">
              <a:rPr lang="es-ES" smtClean="0"/>
              <a:t>28/06/2017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70865-8AB7-497D-8463-1EEFAD81E5C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721752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F43A8F-00EA-452F-8500-B36CBE6266D9}" type="datetimeFigureOut">
              <a:rPr lang="es-ES" smtClean="0"/>
              <a:t>28/06/2017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70865-8AB7-497D-8463-1EEFAD81E5C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875833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F43A8F-00EA-452F-8500-B36CBE6266D9}" type="datetimeFigureOut">
              <a:rPr lang="es-ES" smtClean="0"/>
              <a:t>28/06/2017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70865-8AB7-497D-8463-1EEFAD81E5C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208713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F43A8F-00EA-452F-8500-B36CBE6266D9}" type="datetimeFigureOut">
              <a:rPr lang="es-ES" smtClean="0"/>
              <a:t>28/06/2017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70865-8AB7-497D-8463-1EEFAD81E5C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443226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F43A8F-00EA-452F-8500-B36CBE6266D9}" type="datetimeFigureOut">
              <a:rPr lang="es-ES" smtClean="0"/>
              <a:t>28/06/2017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70865-8AB7-497D-8463-1EEFAD81E5C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815699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F43A8F-00EA-452F-8500-B36CBE6266D9}" type="datetimeFigureOut">
              <a:rPr lang="es-ES" smtClean="0"/>
              <a:t>28/06/2017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70865-8AB7-497D-8463-1EEFAD81E5C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763848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F43A8F-00EA-452F-8500-B36CBE6266D9}" type="datetimeFigureOut">
              <a:rPr lang="es-ES" smtClean="0"/>
              <a:t>28/06/2017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70865-8AB7-497D-8463-1EEFAD81E5C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345329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F43A8F-00EA-452F-8500-B36CBE6266D9}" type="datetimeFigureOut">
              <a:rPr lang="es-ES" smtClean="0"/>
              <a:t>28/06/2017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870865-8AB7-497D-8463-1EEFAD81E5C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673908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4 Grupo"/>
          <p:cNvGrpSpPr/>
          <p:nvPr/>
        </p:nvGrpSpPr>
        <p:grpSpPr>
          <a:xfrm>
            <a:off x="467545" y="1810036"/>
            <a:ext cx="8208911" cy="2304254"/>
            <a:chOff x="467545" y="1810036"/>
            <a:chExt cx="8208911" cy="2304254"/>
          </a:xfrm>
        </p:grpSpPr>
        <p:sp>
          <p:nvSpPr>
            <p:cNvPr id="10" name="9 CuadroTexto"/>
            <p:cNvSpPr txBox="1"/>
            <p:nvPr/>
          </p:nvSpPr>
          <p:spPr>
            <a:xfrm rot="16200000">
              <a:off x="-546082" y="2823663"/>
              <a:ext cx="23042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elative</a:t>
              </a:r>
              <a:r>
                <a:rPr lang="es-E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12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roportion</a:t>
              </a:r>
              <a:r>
                <a:rPr lang="es-E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%)</a:t>
              </a:r>
              <a:endParaRPr lang="es-E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18 CuadroTexto"/>
            <p:cNvSpPr txBox="1"/>
            <p:nvPr/>
          </p:nvSpPr>
          <p:spPr>
            <a:xfrm>
              <a:off x="3817428" y="3837291"/>
              <a:ext cx="18002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Infant</a:t>
              </a:r>
              <a:r>
                <a:rPr lang="es-E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12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ge</a:t>
              </a:r>
              <a:r>
                <a:rPr lang="es-E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s-ES" sz="12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days</a:t>
              </a:r>
              <a:r>
                <a:rPr lang="es-E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s-E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27" name="Picture 3"/>
            <p:cNvPicPr preferRelativeResize="0">
              <a:picLocks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87394" y="2093808"/>
              <a:ext cx="2700000" cy="1944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28" name="Picture 4"/>
            <p:cNvPicPr preferRelativeResize="0">
              <a:picLocks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67528" y="2099075"/>
              <a:ext cx="2700000" cy="1944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" name="Picture 5"/>
            <p:cNvPicPr preferRelativeResize="0">
              <a:picLocks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976456" y="2099348"/>
              <a:ext cx="2700000" cy="1944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11" name="10 Rectángulo"/>
          <p:cNvSpPr/>
          <p:nvPr/>
        </p:nvSpPr>
        <p:spPr>
          <a:xfrm>
            <a:off x="467544" y="116632"/>
            <a:ext cx="8208911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s-ES" dirty="0" smtClean="0">
                <a:latin typeface="Arial" panose="020B0604020202020204" pitchFamily="34" charset="0"/>
                <a:cs typeface="Arial" panose="020B0604020202020204" pitchFamily="34" charset="0"/>
              </a:rPr>
              <a:t>S3. </a:t>
            </a:r>
            <a:r>
              <a:rPr lang="es-E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lative</a:t>
            </a:r>
            <a:r>
              <a:rPr lang="es-E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portions</a:t>
            </a:r>
            <a:r>
              <a:rPr lang="es-ES" dirty="0" smtClean="0">
                <a:latin typeface="Arial" panose="020B0604020202020204" pitchFamily="34" charset="0"/>
                <a:cs typeface="Arial" panose="020B0604020202020204" pitchFamily="34" charset="0"/>
              </a:rPr>
              <a:t> (%) of </a:t>
            </a:r>
            <a:r>
              <a:rPr lang="es-E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es-E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in</a:t>
            </a:r>
            <a:r>
              <a:rPr lang="es-E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CFAs</a:t>
            </a:r>
            <a:r>
              <a:rPr lang="es-ES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E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etate</a:t>
            </a:r>
            <a:r>
              <a:rPr lang="es-ES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s-E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pionate</a:t>
            </a:r>
            <a:r>
              <a:rPr lang="es-ES" dirty="0" smtClean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s-E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utyrate</a:t>
            </a:r>
            <a:r>
              <a:rPr lang="es-ES" dirty="0" smtClean="0">
                <a:latin typeface="Arial" panose="020B0604020202020204" pitchFamily="34" charset="0"/>
                <a:cs typeface="Arial" panose="020B0604020202020204" pitchFamily="34" charset="0"/>
              </a:rPr>
              <a:t>) in </a:t>
            </a:r>
            <a:r>
              <a:rPr lang="es-E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eces</a:t>
            </a:r>
            <a:r>
              <a:rPr lang="es-E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es-E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fants</a:t>
            </a:r>
            <a:r>
              <a:rPr lang="es-E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hose</a:t>
            </a:r>
            <a:r>
              <a:rPr lang="es-E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others</a:t>
            </a:r>
            <a:r>
              <a:rPr lang="es-E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ceived</a:t>
            </a:r>
            <a:r>
              <a:rPr lang="es-E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trapartum</a:t>
            </a:r>
            <a:r>
              <a:rPr lang="es-E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timicrobial</a:t>
            </a:r>
            <a:r>
              <a:rPr lang="es-E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phylaxis</a:t>
            </a:r>
            <a:r>
              <a:rPr lang="es-ES" dirty="0" smtClean="0">
                <a:latin typeface="Arial" panose="020B0604020202020204" pitchFamily="34" charset="0"/>
                <a:cs typeface="Arial" panose="020B0604020202020204" pitchFamily="34" charset="0"/>
              </a:rPr>
              <a:t> (IAP) and </a:t>
            </a:r>
            <a:r>
              <a:rPr lang="es-E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ose</a:t>
            </a:r>
            <a:r>
              <a:rPr lang="es-E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mtClean="0">
                <a:latin typeface="Arial" panose="020B0604020202020204" pitchFamily="34" charset="0"/>
                <a:cs typeface="Arial" panose="020B0604020202020204" pitchFamily="34" charset="0"/>
              </a:rPr>
              <a:t>whose</a:t>
            </a:r>
            <a:r>
              <a:rPr lang="es-E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others</a:t>
            </a:r>
            <a:r>
              <a:rPr lang="es-E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id</a:t>
            </a:r>
            <a:r>
              <a:rPr lang="es-E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t</a:t>
            </a:r>
            <a:r>
              <a:rPr lang="es-ES" dirty="0" smtClean="0">
                <a:latin typeface="Arial" panose="020B0604020202020204" pitchFamily="34" charset="0"/>
                <a:cs typeface="Arial" panose="020B0604020202020204" pitchFamily="34" charset="0"/>
              </a:rPr>
              <a:t> (no IAP).</a:t>
            </a:r>
            <a:endParaRPr lang="es-E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4601779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3</TotalTime>
  <Words>48</Words>
  <Application>Microsoft Office PowerPoint</Application>
  <PresentationFormat>Presentación en pantalla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Gueimonde</dc:creator>
  <cp:lastModifiedBy>MGueimonde</cp:lastModifiedBy>
  <cp:revision>20</cp:revision>
  <cp:lastPrinted>2016-12-01T15:26:24Z</cp:lastPrinted>
  <dcterms:created xsi:type="dcterms:W3CDTF">2016-07-14T07:40:54Z</dcterms:created>
  <dcterms:modified xsi:type="dcterms:W3CDTF">2017-06-28T10:00:00Z</dcterms:modified>
</cp:coreProperties>
</file>